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25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E"/>
    <a:srgbClr val="FE0000"/>
    <a:srgbClr val="00BF00"/>
    <a:srgbClr val="AC06E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D113A9D2-9D6B-4929-AA2D-F23B5EE8CBE7}" styleName="Themed Style 2 - Accent 1">
    <a:tblBg>
      <a:fillRef idx="3">
        <a:schemeClr val="accent1"/>
      </a:fillRef>
      <a:effectRef idx="3">
        <a:schemeClr val="accent1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1">
                <a:tint val="50000"/>
              </a:schemeClr>
            </a:lnRef>
          </a:left>
          <a:right>
            <a:lnRef idx="1">
              <a:schemeClr val="accent1">
                <a:tint val="50000"/>
              </a:schemeClr>
            </a:lnRef>
          </a:right>
          <a:top>
            <a:lnRef idx="1">
              <a:schemeClr val="accent1">
                <a:tint val="50000"/>
              </a:schemeClr>
            </a:lnRef>
          </a:top>
          <a:bottom>
            <a:lnRef idx="1">
              <a:schemeClr val="accent1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613" autoAdjust="0"/>
    <p:restoredTop sz="95380" autoAdjust="0"/>
  </p:normalViewPr>
  <p:slideViewPr>
    <p:cSldViewPr>
      <p:cViewPr varScale="1">
        <p:scale>
          <a:sx n="104" d="100"/>
          <a:sy n="104" d="100"/>
        </p:scale>
        <p:origin x="2910" y="11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5C67A7EB-D8FA-402C-93F1-129C8FDAD13F}" type="datetimeFigureOut">
              <a:rPr lang="en-US" smtClean="0"/>
              <a:pPr/>
              <a:t>1/26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57A75BAE-0FEB-469F-A007-1CB9D3A6AA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70368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20454-B426-4ECC-91E4-7A770F557295}" type="datetimeFigureOut">
              <a:rPr lang="en-US" smtClean="0"/>
              <a:pPr/>
              <a:t>1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16A76-CAB0-4582-8F32-DD40DDCE7E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20454-B426-4ECC-91E4-7A770F557295}" type="datetimeFigureOut">
              <a:rPr lang="en-US" smtClean="0"/>
              <a:pPr/>
              <a:t>1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16A76-CAB0-4582-8F32-DD40DDCE7E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20454-B426-4ECC-91E4-7A770F557295}" type="datetimeFigureOut">
              <a:rPr lang="en-US" smtClean="0"/>
              <a:pPr/>
              <a:t>1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16A76-CAB0-4582-8F32-DD40DDCE7E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20454-B426-4ECC-91E4-7A770F557295}" type="datetimeFigureOut">
              <a:rPr lang="en-US" smtClean="0"/>
              <a:pPr/>
              <a:t>1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16A76-CAB0-4582-8F32-DD40DDCE7E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20454-B426-4ECC-91E4-7A770F557295}" type="datetimeFigureOut">
              <a:rPr lang="en-US" smtClean="0"/>
              <a:pPr/>
              <a:t>1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16A76-CAB0-4582-8F32-DD40DDCE7E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20454-B426-4ECC-91E4-7A770F557295}" type="datetimeFigureOut">
              <a:rPr lang="en-US" smtClean="0"/>
              <a:pPr/>
              <a:t>1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16A76-CAB0-4582-8F32-DD40DDCE7E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20454-B426-4ECC-91E4-7A770F557295}" type="datetimeFigureOut">
              <a:rPr lang="en-US" smtClean="0"/>
              <a:pPr/>
              <a:t>1/26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16A76-CAB0-4582-8F32-DD40DDCE7E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20454-B426-4ECC-91E4-7A770F557295}" type="datetimeFigureOut">
              <a:rPr lang="en-US" smtClean="0"/>
              <a:pPr/>
              <a:t>1/2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16A76-CAB0-4582-8F32-DD40DDCE7E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20454-B426-4ECC-91E4-7A770F557295}" type="datetimeFigureOut">
              <a:rPr lang="en-US" smtClean="0"/>
              <a:pPr/>
              <a:t>1/26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16A76-CAB0-4582-8F32-DD40DDCE7E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8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20454-B426-4ECC-91E4-7A770F557295}" type="datetimeFigureOut">
              <a:rPr lang="en-US" smtClean="0"/>
              <a:pPr/>
              <a:t>1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16A76-CAB0-4582-8F32-DD40DDCE7E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20454-B426-4ECC-91E4-7A770F557295}" type="datetimeFigureOut">
              <a:rPr lang="en-US" smtClean="0"/>
              <a:pPr/>
              <a:t>1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16A76-CAB0-4582-8F32-DD40DDCE7E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920454-B426-4ECC-91E4-7A770F557295}" type="datetimeFigureOut">
              <a:rPr lang="en-US" smtClean="0"/>
              <a:pPr/>
              <a:t>1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E16A76-CAB0-4582-8F32-DD40DDCE7E5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85800" y="457200"/>
            <a:ext cx="61721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1 </a:t>
            </a:r>
            <a:endParaRPr 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80012270"/>
              </p:ext>
            </p:extLst>
          </p:nvPr>
        </p:nvGraphicFramePr>
        <p:xfrm>
          <a:off x="896239" y="1065550"/>
          <a:ext cx="5334290" cy="15697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94080"/>
                <a:gridCol w="1522735"/>
                <a:gridCol w="1522735"/>
                <a:gridCol w="1394740"/>
              </a:tblGrid>
              <a:tr h="370840"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 of Bands </a:t>
                      </a:r>
                    </a:p>
                    <a:p>
                      <a:pPr algn="ctr"/>
                      <a:r>
                        <a:rPr lang="en-US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 Q/C</a:t>
                      </a:r>
                      <a:r>
                        <a:rPr lang="en-US" sz="1200" b="1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Gel</a:t>
                      </a:r>
                      <a:endPara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ount of WGA product (µg)</a:t>
                      </a:r>
                      <a:endPara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of Fragments 100-600bp</a:t>
                      </a:r>
                      <a:endPara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 #1</a:t>
                      </a:r>
                      <a:endPara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.6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.3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 #2</a:t>
                      </a:r>
                      <a:endPara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6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.18</a:t>
                      </a:r>
                    </a:p>
                  </a:txBody>
                  <a:tcPr marL="9525" marR="9525" marT="9525" marB="0"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 #3</a:t>
                      </a:r>
                      <a:endPara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.0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.39</a:t>
                      </a: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057917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906</TotalTime>
  <Words>38</Words>
  <Application>Microsoft Office PowerPoint</Application>
  <PresentationFormat>On-screen Show (4:3)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outline</dc:title>
  <dc:creator>Erica</dc:creator>
  <cp:lastModifiedBy>Stephanie Yee</cp:lastModifiedBy>
  <cp:revision>1176</cp:revision>
  <cp:lastPrinted>2016-01-25T19:44:34Z</cp:lastPrinted>
  <dcterms:created xsi:type="dcterms:W3CDTF">2015-02-12T22:03:54Z</dcterms:created>
  <dcterms:modified xsi:type="dcterms:W3CDTF">2016-01-26T18:00:33Z</dcterms:modified>
</cp:coreProperties>
</file>